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62" r:id="rId6"/>
    <p:sldId id="258" r:id="rId7"/>
    <p:sldId id="269" r:id="rId8"/>
    <p:sldId id="261" r:id="rId9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05" autoAdjust="0"/>
    <p:restoredTop sz="94660"/>
  </p:normalViewPr>
  <p:slideViewPr>
    <p:cSldViewPr snapToGrid="0">
      <p:cViewPr>
        <p:scale>
          <a:sx n="120" d="100"/>
          <a:sy n="120" d="100"/>
        </p:scale>
        <p:origin x="912" y="9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2440516-CC4E-4E30-A3A1-92702C8C6F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0BD838D-0AA4-43E9-87C9-0C1CC394AE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E1A314C-EE5C-41F6-8149-641BA05F0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47A9969-34CF-4A02-9C4B-8A811E4713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8312C00-0695-4C67-A8B7-AD36F2BFC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9369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D3EBC3-F5CE-47BF-A5D4-4A36F27667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89491FC-A6AB-4136-8F26-661DCEA172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9D784E0-D5B9-4091-9E44-1483D976E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21DCCE0-BDE1-4CF2-A712-B4E676ACAA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DE936B0-88F2-4296-84BD-CDD96E894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4609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8D3CE3E-4EF2-456B-A3FF-87C3B97454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B78A1B3-F9D2-4E50-BBA7-F9219D1BA6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71C0C16-807B-4377-890D-0CBAC94D87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0B1A88A-B9C4-44BA-AA3F-CA0FFF9B9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C869A6C-81A4-439E-8D99-FDCF13CDB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1348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1A7DC0B-A25C-407C-BBDD-59ED7B91F7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F943C86-EA48-487B-9DFD-1D22189253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68E1D77-CADD-4433-A0D7-92EF432A8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B489805-D908-46AB-87EE-E86D640384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BFC1536-DD9F-4E35-8D05-BCB9A89AD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34081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E132347-9212-4E52-8279-BA4E5C8332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F6EF77D-5D92-41F3-88D3-0375286F7D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1C3BEBD-0E3C-449C-A4C1-8B4D443643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95649A5-6C74-45D7-A42D-ABA49096B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876AC3-1687-4153-A532-DEB6B78B1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7821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0B52D2D-8C3F-4709-8168-7C894FC2A4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38EA360-FF09-4AF1-8D3C-13E10D040B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7562248-4F82-4B39-B5D0-0AFF3D0E1E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0685FDD-5354-41B0-8E5F-7AD5E79234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D973A8F-8FCE-41CB-998D-B4FAD9339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0C9F108-0282-4471-A95C-A293C6D93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5575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E245B7-408E-45EB-A781-72C3804FED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2C7ED6A-F268-4837-B126-064D1CB275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2A6CBEC-9269-4B51-B80C-04FCD6EB03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89982AC-556E-403D-B567-0C4732B535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FCDB8711-40F2-473F-A486-602ACA4D47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40557540-DB2C-478B-9DCF-D2427221A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F6BADD9-1BE3-42A4-8FE4-7EC3B90A7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80DF4BA-1E3A-43CE-AE57-7642DFFBD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1697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09BBF61-AB77-4B99-9C65-839B410B81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62908866-C7B5-4793-9CE0-5BF1342FF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8C83AD4-6A33-4F0F-9C7F-1BC276478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DCBA2CD-8E9B-4501-ACA8-806B0F9D7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582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DC54CF17-A8D6-4F4D-B796-E85B7CF88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899C3FF-DA51-4FE7-BB17-5D0033701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413AD1C-B75D-41C1-96CE-E61B983139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8627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A022C91-4973-4C81-82AC-59EF2DEA23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B8C4594-EA40-428B-9763-0C9D870C27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90EE9BA-E77B-4DD5-9792-3A1F8337AC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E0A96D2-897B-41D5-BCCD-C1DCEFA14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5089636-41C6-4B9C-8BA8-FDC435B8C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56D65D6-D21D-494A-AB4B-46F8CC7B2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7797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7166F04-EC52-4CBB-8C4C-1EF4002BDB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F33371D-6EC9-4879-BC0B-701B35D987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1C8AB8C-CDAA-41D2-B326-D4A8CA709F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4868F5B-BC1C-4B9C-B56E-EEADA7246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5C54022-73FB-4CD4-846D-E06DD72A6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61DA81F-7275-488D-B440-B9BE3E909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9341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69C440D-5DBE-4907-96C9-E4EFC51152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703A38A-6DDD-437A-B560-AD8B158B4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C096355-E930-4BA3-99DD-E70AC2B2EA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9C2234-7157-433C-BE3A-606629991450}" type="datetimeFigureOut">
              <a:rPr lang="fr-FR" smtClean="0"/>
              <a:t>07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6885298-F4B3-4EFB-A723-69B087D846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AB81CCC-3F09-4F6A-9AEC-9014A1ADD7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1EB829-C22F-4249-B2E2-54C587314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2222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sv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que 4">
            <a:extLst>
              <a:ext uri="{FF2B5EF4-FFF2-40B4-BE49-F238E27FC236}">
                <a16:creationId xmlns:a16="http://schemas.microsoft.com/office/drawing/2014/main" id="{EF5AD29C-7DE7-4CA8-A5C1-B1E8A487A1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125133" y="0"/>
            <a:ext cx="8551333" cy="6841067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F3170B75-8750-4EFF-8A73-808BACB2CB32}"/>
              </a:ext>
            </a:extLst>
          </p:cNvPr>
          <p:cNvSpPr/>
          <p:nvPr/>
        </p:nvSpPr>
        <p:spPr>
          <a:xfrm>
            <a:off x="658709" y="94734"/>
            <a:ext cx="27635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/>
              <a:t>cnetplot_BP_mir143_stress</a:t>
            </a:r>
          </a:p>
        </p:txBody>
      </p:sp>
    </p:spTree>
    <p:extLst>
      <p:ext uri="{BB962C8B-B14F-4D97-AF65-F5344CB8AC3E}">
        <p14:creationId xmlns:p14="http://schemas.microsoft.com/office/powerpoint/2010/main" val="4378835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que 2">
            <a:extLst>
              <a:ext uri="{FF2B5EF4-FFF2-40B4-BE49-F238E27FC236}">
                <a16:creationId xmlns:a16="http://schemas.microsoft.com/office/drawing/2014/main" id="{7F45BDBB-ACFF-4E29-B252-F7069A380F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809750" y="0"/>
            <a:ext cx="8572500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423AA86A-C1F6-472E-99CF-923B787D1732}"/>
              </a:ext>
            </a:extLst>
          </p:cNvPr>
          <p:cNvSpPr/>
          <p:nvPr/>
        </p:nvSpPr>
        <p:spPr>
          <a:xfrm>
            <a:off x="0" y="0"/>
            <a:ext cx="27635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/>
              <a:t>cnetplot_BP_mir155_stress</a:t>
            </a:r>
          </a:p>
        </p:txBody>
      </p:sp>
    </p:spTree>
    <p:extLst>
      <p:ext uri="{BB962C8B-B14F-4D97-AF65-F5344CB8AC3E}">
        <p14:creationId xmlns:p14="http://schemas.microsoft.com/office/powerpoint/2010/main" val="38348223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que 4">
            <a:extLst>
              <a:ext uri="{FF2B5EF4-FFF2-40B4-BE49-F238E27FC236}">
                <a16:creationId xmlns:a16="http://schemas.microsoft.com/office/drawing/2014/main" id="{8224F6B8-67B4-4D54-B1B6-530BC60367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638300" y="0"/>
            <a:ext cx="8915400" cy="68580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006786F8-A305-4D5A-A0EE-91B785AE4E73}"/>
              </a:ext>
            </a:extLst>
          </p:cNvPr>
          <p:cNvSpPr/>
          <p:nvPr/>
        </p:nvSpPr>
        <p:spPr>
          <a:xfrm>
            <a:off x="201240" y="154001"/>
            <a:ext cx="28741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/>
              <a:t>cnetplot_BP_mir200a_stress</a:t>
            </a:r>
          </a:p>
        </p:txBody>
      </p:sp>
    </p:spTree>
    <p:extLst>
      <p:ext uri="{BB962C8B-B14F-4D97-AF65-F5344CB8AC3E}">
        <p14:creationId xmlns:p14="http://schemas.microsoft.com/office/powerpoint/2010/main" val="12463201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que 2">
            <a:extLst>
              <a:ext uri="{FF2B5EF4-FFF2-40B4-BE49-F238E27FC236}">
                <a16:creationId xmlns:a16="http://schemas.microsoft.com/office/drawing/2014/main" id="{559E985F-9142-440D-9E91-995F282FF9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981200" y="0"/>
            <a:ext cx="8229600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1C0C2EF1-D8F9-4C2B-8425-9D8FAF890C32}"/>
              </a:ext>
            </a:extLst>
          </p:cNvPr>
          <p:cNvSpPr/>
          <p:nvPr/>
        </p:nvSpPr>
        <p:spPr>
          <a:xfrm>
            <a:off x="209976" y="128600"/>
            <a:ext cx="27635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/>
              <a:t>cnetplot_BP_mir205_stress</a:t>
            </a:r>
          </a:p>
        </p:txBody>
      </p:sp>
    </p:spTree>
    <p:extLst>
      <p:ext uri="{BB962C8B-B14F-4D97-AF65-F5344CB8AC3E}">
        <p14:creationId xmlns:p14="http://schemas.microsoft.com/office/powerpoint/2010/main" val="18299715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phique 6">
            <a:extLst>
              <a:ext uri="{FF2B5EF4-FFF2-40B4-BE49-F238E27FC236}">
                <a16:creationId xmlns:a16="http://schemas.microsoft.com/office/drawing/2014/main" id="{C0C9BEC1-8A20-43D2-9CA6-24665C0010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981200" y="0"/>
            <a:ext cx="8229600" cy="685800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A3F29A52-7198-4F0C-97BB-199618FC0FFC}"/>
              </a:ext>
            </a:extLst>
          </p:cNvPr>
          <p:cNvSpPr/>
          <p:nvPr/>
        </p:nvSpPr>
        <p:spPr>
          <a:xfrm>
            <a:off x="243843" y="162467"/>
            <a:ext cx="27635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/>
              <a:t>cnetplot_BP_mir223_stress</a:t>
            </a:r>
          </a:p>
        </p:txBody>
      </p:sp>
    </p:spTree>
    <p:extLst>
      <p:ext uri="{BB962C8B-B14F-4D97-AF65-F5344CB8AC3E}">
        <p14:creationId xmlns:p14="http://schemas.microsoft.com/office/powerpoint/2010/main" val="118730213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D92D5A9EE3A2047B39C499EDA9C1FE3" ma:contentTypeVersion="15" ma:contentTypeDescription="Crée un document." ma:contentTypeScope="" ma:versionID="f7259c7cc82a0dc7fb7158bdee0df187">
  <xsd:schema xmlns:xsd="http://www.w3.org/2001/XMLSchema" xmlns:xs="http://www.w3.org/2001/XMLSchema" xmlns:p="http://schemas.microsoft.com/office/2006/metadata/properties" xmlns:ns3="6a2c33e1-cf44-4d96-854b-e05e5f0e1921" xmlns:ns4="f23d8532-e8ca-4353-818f-bb5e8427d662" targetNamespace="http://schemas.microsoft.com/office/2006/metadata/properties" ma:root="true" ma:fieldsID="ec0dffc15260eca704b04afb0038d694" ns3:_="" ns4:_="">
    <xsd:import namespace="6a2c33e1-cf44-4d96-854b-e05e5f0e1921"/>
    <xsd:import namespace="f23d8532-e8ca-4353-818f-bb5e8427d66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LengthInSeconds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a2c33e1-cf44-4d96-854b-e05e5f0e192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7" nillable="true" ma:displayName="Length (seconds)" ma:internalName="MediaLengthInSeconds" ma:readOnly="true">
      <xsd:simpleType>
        <xsd:restriction base="dms:Unknown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23d8532-e8ca-4353-818f-bb5e8427d662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6a2c33e1-cf44-4d96-854b-e05e5f0e1921" xsi:nil="true"/>
  </documentManagement>
</p:properties>
</file>

<file path=customXml/itemProps1.xml><?xml version="1.0" encoding="utf-8"?>
<ds:datastoreItem xmlns:ds="http://schemas.openxmlformats.org/officeDocument/2006/customXml" ds:itemID="{76C64C15-1507-4032-9408-AD272556614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a2c33e1-cf44-4d96-854b-e05e5f0e1921"/>
    <ds:schemaRef ds:uri="f23d8532-e8ca-4353-818f-bb5e8427d66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9721AA1-52FD-49A4-BCA6-95BA942057A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C9D905F-3016-49C0-AA80-78C5D66D6D9C}">
  <ds:schemaRefs>
    <ds:schemaRef ds:uri="http://schemas.microsoft.com/office/2006/documentManagement/types"/>
    <ds:schemaRef ds:uri="http://www.w3.org/XML/1998/namespace"/>
    <ds:schemaRef ds:uri="http://purl.org/dc/elements/1.1/"/>
    <ds:schemaRef ds:uri="http://purl.org/dc/dcmitype/"/>
    <ds:schemaRef ds:uri="http://purl.org/dc/terms/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f23d8532-e8ca-4353-818f-bb5e8427d662"/>
    <ds:schemaRef ds:uri="6a2c33e1-cf44-4d96-854b-e05e5f0e1921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92</TotalTime>
  <Words>35</Words>
  <Application>Microsoft Macintosh PowerPoint</Application>
  <PresentationFormat>Grand écran</PresentationFormat>
  <Paragraphs>5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va Blondeau-bidet</dc:creator>
  <cp:lastModifiedBy>Microsoft Office User</cp:lastModifiedBy>
  <cp:revision>5</cp:revision>
  <dcterms:created xsi:type="dcterms:W3CDTF">2023-02-03T14:09:12Z</dcterms:created>
  <dcterms:modified xsi:type="dcterms:W3CDTF">2023-02-07T10:02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D92D5A9EE3A2047B39C499EDA9C1FE3</vt:lpwstr>
  </property>
</Properties>
</file>